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90DC1-9B77-7BD9-6170-B2CFBF25F2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255FEB-3145-3C74-5520-6972A4709C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5D109-0767-D4C0-77A1-7E5AA3334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93D305-1AA2-7360-9F01-A82ABCBB6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DB9022-D415-7320-CB5A-17F867713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71182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19309-EFB8-7BC8-5B20-18F675E2C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233159-BAF7-6FC4-B0B3-D9E9992334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14790-1E8B-1F0C-6968-AC59DEF1B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E81505-3B38-B6AC-AA2A-EE9DB3A0F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9D78B-7991-868A-CAE2-FC6F1E199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2330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C769E7-1530-306D-834C-FD00CE2B3E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F65B4E-08EB-6C96-BA32-A1695B7D7D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A05CCB-6D40-AEA1-74D9-68F8D36E7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51AD12-F935-D204-5540-1DEC20355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95F22-3E9B-7D8E-C17F-C3EB0B66B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59859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54963-9AAC-A882-F616-E8FA8B3CC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7889E-D84C-55E6-E7E1-D880F7CB27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831C1B-E125-46C1-51C9-14D36AF5A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28B9B-D4A3-C5D1-92B7-92B0E8A3A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D1601-FF4A-B39A-F222-C96CB67D3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241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5D86D0-0CCD-7ADE-DD9C-F21E9C140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293301-B915-5D51-7F31-E85B693C7A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57F92-3FEE-8C77-6160-97C821F5B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248D1-94EB-CB57-479A-8B63E68CD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78834-2EC6-4C82-89F9-A1AFB97DB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5958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C81A2-998A-1333-EC60-6E024C7703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23F8D1-FABE-BE19-E67B-C56F72FD80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3AA133-D936-67DC-C5DA-22C747873E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EA3D83-FD39-FD70-23D5-84D86745D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BE66A-F05D-B37D-AEF6-F5FAF7681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0C7398-164F-9034-FCAF-3E0677972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5141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53BE5-0F7B-1B2E-CDAE-CA33DEA69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8F538-DB85-6E05-8695-1E492844E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11E841-A807-595E-8FF0-6D83FFDB3C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8FC3C2-0365-53FE-6C8C-9598B0EF37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F58A3A-5FE7-39CF-BB51-A45EB48C5C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F3E45-4141-0F0E-A874-D686202DE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E75B63-963D-D67B-58A0-DAFF277DC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7D0906-F55A-37FA-0926-5E1817F7A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8907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22FE48-95E4-A5AC-7FBB-276939AB59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98BCE3-9062-4070-EA64-3DE49BACB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5EACFE-017E-6C0E-9DD6-B28EC5F09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FB3E87-D77F-16B7-70E2-111F48FBC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4782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3BE2B3-1E29-4998-5B94-923084345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00659C-0F3F-F4D4-206D-74FB5E82F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EED96C-CAE4-0F8F-E993-1B579FF55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7068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87074-2198-6337-DE5B-48A4C71A3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6FA800-5E42-F0AF-78AD-88F9AA0B59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012EE9-FCE7-1B9E-4607-BBE1E7FAA2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D1590F-56E4-C15B-F5F8-BC62ADEB8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2790D7-BB39-D5F4-3434-B677FC6E1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1CCE03-CD66-C900-B3A4-A663B2D3F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827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5AB802-4292-A1B6-3D8F-6D603BE67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DB9400-A11C-2388-B7C9-6560FE6653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862E5D-0869-45DF-CB57-17AA67FFE7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B4638B-F3FE-54AC-AC79-F452C2AC8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E0EF2F-ADA6-9C9C-6D82-91E58DE68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4C5869-DA31-14D5-350E-6D934823A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150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50B38E-89E4-BAA6-F613-4D6691CAE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4F353-8E9A-0F02-DCBB-6049A7906E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27A2E5-AD44-C14B-C4BC-5E974C207A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663779-0994-4AF1-AF14-54D0D8F4F08D}" type="datetimeFigureOut">
              <a:rPr lang="en-CA" smtClean="0"/>
              <a:t>2025-09-1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B550F2-6DF6-61FF-3A7E-786E6A6E05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4BA8B7-B1C6-95C4-427E-EF78B94D8C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3ABCED-73F3-4E65-AA77-1D9543BA275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16374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FFCC3B2B-3361-AC8B-E044-7AC7E70F3ECA}"/>
              </a:ext>
            </a:extLst>
          </p:cNvPr>
          <p:cNvGrpSpPr/>
          <p:nvPr/>
        </p:nvGrpSpPr>
        <p:grpSpPr>
          <a:xfrm>
            <a:off x="1038205" y="313100"/>
            <a:ext cx="9384664" cy="5192963"/>
            <a:chOff x="693401" y="549076"/>
            <a:chExt cx="8450530" cy="4511710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A27CA706-5126-0B08-4116-0BF757F898B8}"/>
                </a:ext>
              </a:extLst>
            </p:cNvPr>
            <p:cNvGrpSpPr/>
            <p:nvPr/>
          </p:nvGrpSpPr>
          <p:grpSpPr>
            <a:xfrm>
              <a:off x="693401" y="549076"/>
              <a:ext cx="8450530" cy="4511710"/>
              <a:chOff x="693401" y="549076"/>
              <a:chExt cx="8450530" cy="4511710"/>
            </a:xfrm>
          </p:grpSpPr>
          <p:pic>
            <p:nvPicPr>
              <p:cNvPr id="7" name="Graphic 6">
                <a:extLst>
                  <a:ext uri="{FF2B5EF4-FFF2-40B4-BE49-F238E27FC236}">
                    <a16:creationId xmlns:a16="http://schemas.microsoft.com/office/drawing/2014/main" id="{1729CA86-60C3-F15B-0C29-AAD7F8AB80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rcRect l="17843" t="42718" b="9591"/>
              <a:stretch>
                <a:fillRect/>
              </a:stretch>
            </p:blipFill>
            <p:spPr>
              <a:xfrm>
                <a:off x="693401" y="549076"/>
                <a:ext cx="8450530" cy="4511710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FD05BB5A-2778-3B8B-6A8C-202BDA4FD96C}"/>
                  </a:ext>
                </a:extLst>
              </p:cNvPr>
              <p:cNvSpPr/>
              <p:nvPr/>
            </p:nvSpPr>
            <p:spPr>
              <a:xfrm>
                <a:off x="773723" y="572756"/>
                <a:ext cx="371789" cy="42203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pic>
          <p:nvPicPr>
            <p:cNvPr id="8" name="Graphic 7">
              <a:extLst>
                <a:ext uri="{FF2B5EF4-FFF2-40B4-BE49-F238E27FC236}">
                  <a16:creationId xmlns:a16="http://schemas.microsoft.com/office/drawing/2014/main" id="{5CBB12CD-EC43-15D9-AA60-794A662278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17576" t="97120" r="34708" b="-1"/>
            <a:stretch>
              <a:fillRect/>
            </a:stretch>
          </p:blipFill>
          <p:spPr>
            <a:xfrm>
              <a:off x="5171768" y="616371"/>
              <a:ext cx="3454147" cy="191802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EB56389E-A89A-2DE2-2BF0-A3A7F9D1D8DA}"/>
              </a:ext>
            </a:extLst>
          </p:cNvPr>
          <p:cNvSpPr txBox="1"/>
          <p:nvPr/>
        </p:nvSpPr>
        <p:spPr>
          <a:xfrm>
            <a:off x="1540293" y="5821113"/>
            <a:ext cx="845053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CA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16,145 pan-genomic clusters of 54 </a:t>
            </a:r>
            <a:r>
              <a:rPr lang="en-CA" sz="1800" i="1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Pst</a:t>
            </a:r>
            <a:r>
              <a:rPr lang="en-CA" sz="1800" i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 </a:t>
            </a:r>
            <a:r>
              <a:rPr lang="en-CA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and </a:t>
            </a:r>
            <a:r>
              <a:rPr lang="en-CA" sz="1800" i="1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Psh</a:t>
            </a:r>
            <a:r>
              <a:rPr lang="en-CA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ptos" panose="020B0004020202020204" pitchFamily="34" charset="0"/>
              </a:rPr>
              <a:t> haplotypic, scaffold-phased and annotated genomes are aligned on the chromosome location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401381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, Meng</dc:creator>
  <cp:lastModifiedBy>Li, Meng</cp:lastModifiedBy>
  <cp:revision>1</cp:revision>
  <dcterms:created xsi:type="dcterms:W3CDTF">2025-09-18T21:34:37Z</dcterms:created>
  <dcterms:modified xsi:type="dcterms:W3CDTF">2025-09-18T21:57:32Z</dcterms:modified>
</cp:coreProperties>
</file>